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56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49" d="100"/>
          <a:sy n="149" d="100"/>
        </p:scale>
        <p:origin x="2068" y="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05/01/2026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1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1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1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1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1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1/2026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1/2026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1/2026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1/2026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1/2026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1/2026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5/01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32552" y="5302949"/>
            <a:ext cx="7003744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Lal et al (2026) Diabetologia DOI 10.1007/s00125-025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64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8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6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Example of insulin delivery without meal announcement in users with long-standing</a:t>
            </a:r>
          </a:p>
          <a:p>
            <a:r>
              <a:rPr lang="en-US" sz="1800" b="1" dirty="0"/>
              <a:t>type 1 diabetes</a:t>
            </a:r>
            <a:endParaRPr lang="en-GB" sz="1800" b="1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148DAAB2-5823-A23C-98ED-176C7C85C65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7544" y="1484784"/>
            <a:ext cx="3934862" cy="3528392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EF9A430E-20AD-6B93-19D6-135E0F9D794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572000" y="2508154"/>
            <a:ext cx="4419827" cy="15812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251520" y="272842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tepwise pathway towards automated insulin delivery (AID) without meal announcement as conceptualised in the open-source AID framework</a:t>
            </a:r>
            <a:endParaRPr lang="en-GB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46E8C2BA-6F0A-A8C3-8B1B-E61002FC928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46628" y="1268760"/>
            <a:ext cx="7050743" cy="4176464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CBFA7E4D-D4E3-EAAD-722C-EBDB9FE3AE42}"/>
              </a:ext>
            </a:extLst>
          </p:cNvPr>
          <p:cNvSpPr txBox="1"/>
          <p:nvPr/>
        </p:nvSpPr>
        <p:spPr>
          <a:xfrm>
            <a:off x="232552" y="5302949"/>
            <a:ext cx="7003744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Lal et al (2026) Diabetologia DOI 10.1007/s00125-025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64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8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6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4</Words>
  <Application>Microsoft Office PowerPoint</Application>
  <PresentationFormat>On-screen Show (4:3)</PresentationFormat>
  <Paragraphs>12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Editorial Office</cp:lastModifiedBy>
  <cp:revision>50</cp:revision>
  <dcterms:created xsi:type="dcterms:W3CDTF">2016-06-15T12:53:43Z</dcterms:created>
  <dcterms:modified xsi:type="dcterms:W3CDTF">2026-01-05T12:38:36Z</dcterms:modified>
</cp:coreProperties>
</file>